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79ABF0-FD77-4290-93B5-EC09832C2C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18125-AF3B-4BEC-BC2E-3647F97914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956EA4-6B4B-4157-A06E-9021282189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ED286-8A4C-4CE0-8154-B6E6BE0285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B9B55-3AF3-4668-9764-8AAFA03932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19084B-6AE5-455E-9C61-AFA5A5900A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7909D0-065C-45BE-8249-644243609E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1BEF4C-37AD-4169-B9EB-B6AD64711A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FC5418-3BFA-4631-B111-3F6BF6E26F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FE0D0-A780-4ACC-9B17-B1A801F0C8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A4DF3D-6807-47D0-8F06-0E2CEFC66C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2B7BF-E6C1-4C38-999C-66F73684C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90135E-5B1D-4E06-95E6-D96E2EC52247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8" descr=""/>
          <p:cNvPicPr/>
          <p:nvPr/>
        </p:nvPicPr>
        <p:blipFill>
          <a:blip r:embed="rId1"/>
          <a:stretch/>
        </p:blipFill>
        <p:spPr>
          <a:xfrm>
            <a:off x="108000" y="1469880"/>
            <a:ext cx="8736120" cy="4480200"/>
          </a:xfrm>
          <a:prstGeom prst="rect">
            <a:avLst/>
          </a:prstGeom>
          <a:ln w="0">
            <a:noFill/>
          </a:ln>
        </p:spPr>
      </p:pic>
      <p:sp>
        <p:nvSpPr>
          <p:cNvPr id="42" name="TextBox 1"/>
          <p:cNvSpPr/>
          <p:nvPr/>
        </p:nvSpPr>
        <p:spPr>
          <a:xfrm>
            <a:off x="108000" y="5950080"/>
            <a:ext cx="892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upplementary Figure 3. Annotation for NWR association in region surrounding rs2192161. Linkage disequilibrium is represented by r2. No non-synonymous coding SNPs can be observ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8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1T15:30:57Z</dcterms:created>
  <dc:creator>mluciano</dc:creator>
  <dc:description/>
  <dc:language>en-US</dc:language>
  <cp:lastModifiedBy>LUCIANO Michelle</cp:lastModifiedBy>
  <dcterms:modified xsi:type="dcterms:W3CDTF">2013-04-19T08:34:32Z</dcterms:modified>
  <cp:revision>12</cp:revision>
  <dc:subject/>
  <dc:title>Slide 1</dc:title>
</cp:coreProperties>
</file>